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1" r:id="rId1"/>
  </p:sldMasterIdLst>
  <p:notesMasterIdLst>
    <p:notesMasterId r:id="rId3"/>
  </p:notesMasterIdLst>
  <p:sldIdLst>
    <p:sldId id="265" r:id="rId2"/>
  </p:sldIdLst>
  <p:sldSz cx="6858000" cy="9906000" type="A4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00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ile medio 2 - Colore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Nessuno stile, nessuna griglia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4739"/>
    <p:restoredTop sz="96006" autoAdjust="0"/>
  </p:normalViewPr>
  <p:slideViewPr>
    <p:cSldViewPr snapToGrid="0">
      <p:cViewPr varScale="1">
        <p:scale>
          <a:sx n="78" d="100"/>
          <a:sy n="78" d="100"/>
        </p:scale>
        <p:origin x="3208" y="16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90" d="100"/>
        <a:sy n="19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ntestazion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it-IT"/>
          </a:p>
        </p:txBody>
      </p:sp>
      <p:sp>
        <p:nvSpPr>
          <p:cNvPr id="3" name="Segnaposto dat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B43CAF7-936F-5F44-9B2B-A9102139FCC4}" type="datetimeFigureOut">
              <a:rPr lang="it-IT" smtClean="0"/>
              <a:t>01/04/23</a:t>
            </a:fld>
            <a:endParaRPr lang="it-IT"/>
          </a:p>
        </p:txBody>
      </p:sp>
      <p:sp>
        <p:nvSpPr>
          <p:cNvPr id="4" name="Segnaposto immagin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it-IT"/>
          </a:p>
        </p:txBody>
      </p:sp>
      <p:sp>
        <p:nvSpPr>
          <p:cNvPr id="5" name="Segnaposto note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A47640C-96A2-B84B-B71B-2578F2D698B8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87047684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it-IT"/>
              <a:t>Fare clic per modificare lo stile del sottotitolo dello schema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4DF0CD-08F1-E84B-BDC6-92D89A5A6A39}" type="datetimeFigureOut">
              <a:rPr lang="it-IT" smtClean="0"/>
              <a:t>01/04/23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EA9CDD-6DDF-734D-9E3C-4B1C8B84538A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48975048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4DF0CD-08F1-E84B-BDC6-92D89A5A6A39}" type="datetimeFigureOut">
              <a:rPr lang="it-IT" smtClean="0"/>
              <a:t>01/04/23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EA9CDD-6DDF-734D-9E3C-4B1C8B84538A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69039248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4DF0CD-08F1-E84B-BDC6-92D89A5A6A39}" type="datetimeFigureOut">
              <a:rPr lang="it-IT" smtClean="0"/>
              <a:t>01/04/23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EA9CDD-6DDF-734D-9E3C-4B1C8B84538A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17530163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4DF0CD-08F1-E84B-BDC6-92D89A5A6A39}" type="datetimeFigureOut">
              <a:rPr lang="it-IT" smtClean="0"/>
              <a:t>01/04/23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EA9CDD-6DDF-734D-9E3C-4B1C8B84538A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6210639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4DF0CD-08F1-E84B-BDC6-92D89A5A6A39}" type="datetimeFigureOut">
              <a:rPr lang="it-IT" smtClean="0"/>
              <a:t>01/04/23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EA9CDD-6DDF-734D-9E3C-4B1C8B84538A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21856303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4DF0CD-08F1-E84B-BDC6-92D89A5A6A39}" type="datetimeFigureOut">
              <a:rPr lang="it-IT" smtClean="0"/>
              <a:t>01/04/23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EA9CDD-6DDF-734D-9E3C-4B1C8B84538A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77008770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4DF0CD-08F1-E84B-BDC6-92D89A5A6A39}" type="datetimeFigureOut">
              <a:rPr lang="it-IT" smtClean="0"/>
              <a:t>01/04/23</a:t>
            </a:fld>
            <a:endParaRPr lang="it-IT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EA9CDD-6DDF-734D-9E3C-4B1C8B84538A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23018932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4DF0CD-08F1-E84B-BDC6-92D89A5A6A39}" type="datetimeFigureOut">
              <a:rPr lang="it-IT" smtClean="0"/>
              <a:t>01/04/23</a:t>
            </a:fld>
            <a:endParaRPr lang="it-IT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EA9CDD-6DDF-734D-9E3C-4B1C8B84538A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55136779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4DF0CD-08F1-E84B-BDC6-92D89A5A6A39}" type="datetimeFigureOut">
              <a:rPr lang="it-IT" smtClean="0"/>
              <a:t>01/04/23</a:t>
            </a:fld>
            <a:endParaRPr lang="it-IT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EA9CDD-6DDF-734D-9E3C-4B1C8B84538A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52787687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4DF0CD-08F1-E84B-BDC6-92D89A5A6A39}" type="datetimeFigureOut">
              <a:rPr lang="it-IT" smtClean="0"/>
              <a:t>01/04/23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EA9CDD-6DDF-734D-9E3C-4B1C8B84538A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37025402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it-IT"/>
              <a:t>Fare clic sull'icona per inserire un'immagi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4DF0CD-08F1-E84B-BDC6-92D89A5A6A39}" type="datetimeFigureOut">
              <a:rPr lang="it-IT" smtClean="0"/>
              <a:t>01/04/23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EA9CDD-6DDF-734D-9E3C-4B1C8B84538A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14873803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24DF0CD-08F1-E84B-BDC6-92D89A5A6A39}" type="datetimeFigureOut">
              <a:rPr lang="it-IT" smtClean="0"/>
              <a:t>01/04/23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4EA9CDD-6DDF-734D-9E3C-4B1C8B84538A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48444197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2" r:id="rId1"/>
    <p:sldLayoutId id="2147483673" r:id="rId2"/>
    <p:sldLayoutId id="2147483674" r:id="rId3"/>
    <p:sldLayoutId id="2147483675" r:id="rId4"/>
    <p:sldLayoutId id="2147483676" r:id="rId5"/>
    <p:sldLayoutId id="2147483677" r:id="rId6"/>
    <p:sldLayoutId id="2147483678" r:id="rId7"/>
    <p:sldLayoutId id="2147483679" r:id="rId8"/>
    <p:sldLayoutId id="2147483680" r:id="rId9"/>
    <p:sldLayoutId id="2147483681" r:id="rId10"/>
    <p:sldLayoutId id="2147483682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CasellaDiTesto 3">
            <a:extLst>
              <a:ext uri="{FF2B5EF4-FFF2-40B4-BE49-F238E27FC236}">
                <a16:creationId xmlns:a16="http://schemas.microsoft.com/office/drawing/2014/main" id="{331FDB03-3590-DDFC-4611-A4EC66A3F153}"/>
              </a:ext>
            </a:extLst>
          </p:cNvPr>
          <p:cNvSpPr txBox="1"/>
          <p:nvPr/>
        </p:nvSpPr>
        <p:spPr>
          <a:xfrm>
            <a:off x="248782" y="501996"/>
            <a:ext cx="1151792" cy="169277"/>
          </a:xfrm>
          <a:prstGeom prst="rect">
            <a:avLst/>
          </a:prstGeom>
          <a:solidFill>
            <a:schemeClr val="accent5">
              <a:lumMod val="20000"/>
              <a:lumOff val="80000"/>
            </a:schemeClr>
          </a:solidFill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it-IT" sz="500" b="1" dirty="0">
                <a:latin typeface="Arial" panose="020B0604020202020204" pitchFamily="34" charset="0"/>
                <a:cs typeface="Arial" panose="020B0604020202020204" pitchFamily="34" charset="0"/>
              </a:rPr>
              <a:t>0&lt;</a:t>
            </a:r>
            <a:r>
              <a:rPr lang="it-IT" sz="500" b="1" dirty="0" err="1">
                <a:latin typeface="Arial" panose="020B0604020202020204" pitchFamily="34" charset="0"/>
                <a:cs typeface="Arial" panose="020B0604020202020204" pitchFamily="34" charset="0"/>
              </a:rPr>
              <a:t>nM</a:t>
            </a:r>
            <a:r>
              <a:rPr lang="it-IT" sz="500" b="1" dirty="0">
                <a:latin typeface="Arial" panose="020B0604020202020204" pitchFamily="34" charset="0"/>
                <a:cs typeface="Arial" panose="020B0604020202020204" pitchFamily="34" charset="0"/>
              </a:rPr>
              <a:t>&lt;5 </a:t>
            </a:r>
            <a:r>
              <a:rPr lang="it-IT" sz="500" b="1" dirty="0" err="1">
                <a:latin typeface="Arial" panose="020B0604020202020204" pitchFamily="34" charset="0"/>
                <a:cs typeface="Arial" panose="020B0604020202020204" pitchFamily="34" charset="0"/>
              </a:rPr>
              <a:t>nM</a:t>
            </a:r>
            <a:r>
              <a:rPr lang="it-IT" sz="500" b="1" dirty="0">
                <a:latin typeface="Arial" panose="020B0604020202020204" pitchFamily="34" charset="0"/>
                <a:cs typeface="Arial" panose="020B0604020202020204" pitchFamily="34" charset="0"/>
              </a:rPr>
              <a:t> sensitive</a:t>
            </a:r>
          </a:p>
        </p:txBody>
      </p:sp>
      <p:graphicFrame>
        <p:nvGraphicFramePr>
          <p:cNvPr id="5" name="Tabella 4">
            <a:extLst>
              <a:ext uri="{FF2B5EF4-FFF2-40B4-BE49-F238E27FC236}">
                <a16:creationId xmlns:a16="http://schemas.microsoft.com/office/drawing/2014/main" id="{AF3DD35F-C095-76B1-832B-369566E6D2FD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276618247"/>
              </p:ext>
            </p:extLst>
          </p:nvPr>
        </p:nvGraphicFramePr>
        <p:xfrm>
          <a:off x="238691" y="1154273"/>
          <a:ext cx="6327209" cy="1228202"/>
        </p:xfrm>
        <a:graphic>
          <a:graphicData uri="http://schemas.openxmlformats.org/drawingml/2006/table">
            <a:tbl>
              <a:tblPr>
                <a:tableStyleId>{B301B821-A1FF-4177-AEE7-76D212191A09}</a:tableStyleId>
              </a:tblPr>
              <a:tblGrid>
                <a:gridCol w="1159350">
                  <a:extLst>
                    <a:ext uri="{9D8B030D-6E8A-4147-A177-3AD203B41FA5}">
                      <a16:colId xmlns:a16="http://schemas.microsoft.com/office/drawing/2014/main" val="1250159980"/>
                    </a:ext>
                  </a:extLst>
                </a:gridCol>
                <a:gridCol w="672642">
                  <a:extLst>
                    <a:ext uri="{9D8B030D-6E8A-4147-A177-3AD203B41FA5}">
                      <a16:colId xmlns:a16="http://schemas.microsoft.com/office/drawing/2014/main" val="3612757792"/>
                    </a:ext>
                  </a:extLst>
                </a:gridCol>
                <a:gridCol w="554154">
                  <a:extLst>
                    <a:ext uri="{9D8B030D-6E8A-4147-A177-3AD203B41FA5}">
                      <a16:colId xmlns:a16="http://schemas.microsoft.com/office/drawing/2014/main" val="2360542432"/>
                    </a:ext>
                  </a:extLst>
                </a:gridCol>
                <a:gridCol w="656236">
                  <a:extLst>
                    <a:ext uri="{9D8B030D-6E8A-4147-A177-3AD203B41FA5}">
                      <a16:colId xmlns:a16="http://schemas.microsoft.com/office/drawing/2014/main" val="1128422316"/>
                    </a:ext>
                  </a:extLst>
                </a:gridCol>
                <a:gridCol w="568739">
                  <a:extLst>
                    <a:ext uri="{9D8B030D-6E8A-4147-A177-3AD203B41FA5}">
                      <a16:colId xmlns:a16="http://schemas.microsoft.com/office/drawing/2014/main" val="2428124291"/>
                    </a:ext>
                  </a:extLst>
                </a:gridCol>
                <a:gridCol w="619778">
                  <a:extLst>
                    <a:ext uri="{9D8B030D-6E8A-4147-A177-3AD203B41FA5}">
                      <a16:colId xmlns:a16="http://schemas.microsoft.com/office/drawing/2014/main" val="2775563878"/>
                    </a:ext>
                  </a:extLst>
                </a:gridCol>
                <a:gridCol w="532280">
                  <a:extLst>
                    <a:ext uri="{9D8B030D-6E8A-4147-A177-3AD203B41FA5}">
                      <a16:colId xmlns:a16="http://schemas.microsoft.com/office/drawing/2014/main" val="3697051229"/>
                    </a:ext>
                  </a:extLst>
                </a:gridCol>
                <a:gridCol w="524989">
                  <a:extLst>
                    <a:ext uri="{9D8B030D-6E8A-4147-A177-3AD203B41FA5}">
                      <a16:colId xmlns:a16="http://schemas.microsoft.com/office/drawing/2014/main" val="535906989"/>
                    </a:ext>
                  </a:extLst>
                </a:gridCol>
                <a:gridCol w="475771">
                  <a:extLst>
                    <a:ext uri="{9D8B030D-6E8A-4147-A177-3AD203B41FA5}">
                      <a16:colId xmlns:a16="http://schemas.microsoft.com/office/drawing/2014/main" val="1069509380"/>
                    </a:ext>
                  </a:extLst>
                </a:gridCol>
                <a:gridCol w="563270">
                  <a:extLst>
                    <a:ext uri="{9D8B030D-6E8A-4147-A177-3AD203B41FA5}">
                      <a16:colId xmlns:a16="http://schemas.microsoft.com/office/drawing/2014/main" val="939598353"/>
                    </a:ext>
                  </a:extLst>
                </a:gridCol>
              </a:tblGrid>
              <a:tr h="176567">
                <a:tc>
                  <a:txBody>
                    <a:bodyPr/>
                    <a:lstStyle/>
                    <a:p>
                      <a:pPr algn="ctr" fontAlgn="b"/>
                      <a:r>
                        <a:rPr lang="it-IT" sz="5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C50 </a:t>
                      </a:r>
                      <a:r>
                        <a:rPr lang="it-IT" sz="500" b="1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verage</a:t>
                      </a:r>
                      <a:r>
                        <a:rPr lang="it-IT" sz="5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it-IT" sz="500" b="1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xperiments</a:t>
                      </a:r>
                      <a:r>
                        <a:rPr lang="it-IT" sz="5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</a:p>
                    <a:p>
                      <a:pPr algn="ctr" fontAlgn="b"/>
                      <a:r>
                        <a:rPr lang="it-IT" sz="500" b="1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a</a:t>
                      </a:r>
                      <a:r>
                        <a:rPr lang="it-IT" sz="5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/F3 </a:t>
                      </a:r>
                      <a:r>
                        <a:rPr lang="it-IT" sz="500" b="1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ells</a:t>
                      </a:r>
                      <a:r>
                        <a:rPr lang="it-IT" sz="5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(</a:t>
                      </a:r>
                      <a:r>
                        <a:rPr lang="it-IT" sz="500" b="1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M</a:t>
                      </a:r>
                      <a:r>
                        <a:rPr lang="it-IT" sz="5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</a:t>
                      </a:r>
                      <a:endParaRPr lang="it-IT" sz="500" b="1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117" marR="5117" marT="511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500" b="1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rdafitinib</a:t>
                      </a:r>
                      <a:endParaRPr lang="it-IT" sz="5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117" marR="5117" marT="511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5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nfigratinib</a:t>
                      </a:r>
                      <a:endParaRPr lang="it-IT" sz="5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117" marR="5117" marT="511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5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emigatinib</a:t>
                      </a:r>
                      <a:endParaRPr lang="it-IT" sz="5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117" marR="5117" marT="511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5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ogaratinib</a:t>
                      </a:r>
                      <a:endParaRPr lang="it-IT" sz="5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117" marR="5117" marT="511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500" b="1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utibatinib</a:t>
                      </a:r>
                      <a:endParaRPr lang="it-IT" sz="5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117" marR="5117" marT="511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5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erazantinib</a:t>
                      </a:r>
                      <a:endParaRPr lang="it-IT" sz="5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117" marR="5117" marT="511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5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ZD4547</a:t>
                      </a:r>
                      <a:endParaRPr lang="it-IT" sz="5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117" marR="5117" marT="511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500" b="1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Zoligratinib</a:t>
                      </a:r>
                      <a:endParaRPr lang="it-IT" sz="5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117" marR="5117" marT="511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5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Y2874455</a:t>
                      </a:r>
                      <a:endParaRPr lang="it-IT" sz="5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117" marR="5117" marT="511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389400530"/>
                  </a:ext>
                </a:extLst>
              </a:tr>
              <a:tr h="117287">
                <a:tc>
                  <a:txBody>
                    <a:bodyPr/>
                    <a:lstStyle/>
                    <a:p>
                      <a:pPr algn="ctr" fontAlgn="b"/>
                      <a:r>
                        <a:rPr lang="it-IT" sz="500" b="1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a</a:t>
                      </a:r>
                      <a:r>
                        <a:rPr lang="it-IT" sz="5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/F3 Parental</a:t>
                      </a:r>
                      <a:endParaRPr lang="it-IT" sz="500" b="1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117" marR="5117" marT="511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5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352.2</a:t>
                      </a:r>
                      <a:endParaRPr lang="it-IT" sz="500" b="1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117" marR="5117" marT="511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5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68.9</a:t>
                      </a:r>
                      <a:endParaRPr lang="it-IT" sz="500" b="1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117" marR="5117" marT="511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5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292.4</a:t>
                      </a:r>
                      <a:endParaRPr lang="it-IT" sz="500" b="1" i="0" u="none" strike="noStrike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117" marR="5117" marT="511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5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896</a:t>
                      </a:r>
                      <a:endParaRPr lang="it-IT" sz="500" b="1" i="0" u="none" strike="noStrike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117" marR="5117" marT="511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5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588.7</a:t>
                      </a:r>
                      <a:endParaRPr lang="it-IT" sz="500" b="1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117" marR="5117" marT="511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5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61</a:t>
                      </a:r>
                      <a:endParaRPr lang="it-IT" sz="500" b="1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117" marR="5117" marT="511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5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569.6</a:t>
                      </a:r>
                      <a:endParaRPr lang="it-IT" sz="500" b="1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117" marR="5117" marT="511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5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127</a:t>
                      </a:r>
                      <a:endParaRPr lang="it-IT" sz="500" b="1" i="0" u="none" strike="noStrike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117" marR="5117" marT="511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5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7.5</a:t>
                      </a:r>
                      <a:endParaRPr lang="it-IT" sz="500" b="1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117" marR="5117" marT="511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925970014"/>
                  </a:ext>
                </a:extLst>
              </a:tr>
              <a:tr h="133514">
                <a:tc>
                  <a:txBody>
                    <a:bodyPr/>
                    <a:lstStyle/>
                    <a:p>
                      <a:pPr algn="ctr" fontAlgn="b"/>
                      <a:r>
                        <a:rPr lang="it-IT" sz="5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GFR3::TACC3 WT</a:t>
                      </a:r>
                      <a:endParaRPr lang="it-IT" sz="500" b="1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117" marR="5117" marT="511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5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2</a:t>
                      </a:r>
                      <a:endParaRPr lang="it-IT" sz="500" b="1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117" marR="5117" marT="511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5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2</a:t>
                      </a:r>
                      <a:endParaRPr lang="it-IT" sz="500" b="1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117" marR="5117" marT="511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5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5</a:t>
                      </a:r>
                      <a:endParaRPr lang="it-IT" sz="500" b="1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117" marR="5117" marT="511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5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.4</a:t>
                      </a:r>
                      <a:endParaRPr lang="it-IT" sz="500" b="1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117" marR="5117" marT="511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00B0F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5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3</a:t>
                      </a:r>
                      <a:endParaRPr lang="it-IT" sz="500" b="1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117" marR="5117" marT="511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5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3</a:t>
                      </a:r>
                      <a:endParaRPr lang="it-IT" sz="500" b="1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117" marR="5117" marT="511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500" b="1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3</a:t>
                      </a:r>
                      <a:endParaRPr lang="it-IT" sz="500" b="1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117" marR="5117" marT="511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5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5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.8</a:t>
                      </a:r>
                      <a:endParaRPr lang="it-IT" sz="500" b="1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117" marR="5117" marT="511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00B0F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5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r>
                        <a:rPr lang="it-IT" sz="500" b="1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.p</a:t>
                      </a:r>
                      <a:r>
                        <a:rPr lang="it-IT" sz="5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.</a:t>
                      </a:r>
                      <a:endParaRPr lang="it-IT" sz="500" b="1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117" marR="5117" marT="511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522259601"/>
                  </a:ext>
                </a:extLst>
              </a:tr>
              <a:tr h="133264">
                <a:tc>
                  <a:txBody>
                    <a:bodyPr/>
                    <a:lstStyle/>
                    <a:p>
                      <a:pPr algn="ctr" fontAlgn="b"/>
                      <a:r>
                        <a:rPr lang="it-IT" sz="5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GFR3::TACC3 N540K</a:t>
                      </a:r>
                      <a:endParaRPr lang="it-IT" sz="500" b="1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117" marR="5117" marT="511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500" b="1" u="none" strike="noStrike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5.9</a:t>
                      </a:r>
                      <a:endParaRPr lang="it-IT" sz="500" b="1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117" marR="5117" marT="511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0070C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500" b="1" u="none" strike="noStrike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33.4</a:t>
                      </a:r>
                      <a:endParaRPr lang="it-IT" sz="500" b="1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117" marR="5117" marT="511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0070C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500" b="1" u="none" strike="noStrike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52.1</a:t>
                      </a:r>
                      <a:endParaRPr lang="it-IT" sz="500" b="1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117" marR="5117" marT="511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0070C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500" b="1" u="none" strike="noStrike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611.6</a:t>
                      </a:r>
                      <a:endParaRPr lang="it-IT" sz="500" b="1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117" marR="5117" marT="511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0070C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5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9.5</a:t>
                      </a:r>
                      <a:endParaRPr lang="it-IT" sz="500" b="1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117" marR="5117" marT="511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00B0F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500" b="1" u="none" strike="noStrike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24.5</a:t>
                      </a:r>
                      <a:endParaRPr lang="it-IT" sz="500" b="1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117" marR="5117" marT="511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5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500" b="1" u="none" strike="noStrike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22.5</a:t>
                      </a:r>
                      <a:endParaRPr lang="it-IT" sz="500" b="1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117" marR="5117" marT="511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0070C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500" b="1" u="none" strike="noStrike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484</a:t>
                      </a:r>
                      <a:endParaRPr lang="it-IT" sz="500" b="1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117" marR="5117" marT="511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0070C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t-IT" sz="5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r>
                        <a:rPr lang="it-IT" sz="500" b="1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.p</a:t>
                      </a:r>
                      <a:r>
                        <a:rPr lang="it-IT" sz="5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. </a:t>
                      </a:r>
                      <a:endParaRPr lang="it-IT" sz="500" b="1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117" marR="5117" marT="511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153283086"/>
                  </a:ext>
                </a:extLst>
              </a:tr>
              <a:tr h="133514">
                <a:tc>
                  <a:txBody>
                    <a:bodyPr/>
                    <a:lstStyle/>
                    <a:p>
                      <a:pPr algn="ctr" fontAlgn="b"/>
                      <a:r>
                        <a:rPr lang="it-IT" sz="5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GFR3::TACC3 V553L</a:t>
                      </a:r>
                      <a:endParaRPr lang="it-IT" sz="500" b="1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117" marR="5117" marT="511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5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5</a:t>
                      </a:r>
                      <a:endParaRPr lang="it-IT" sz="500" b="1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117" marR="5117" marT="511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5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5</a:t>
                      </a:r>
                      <a:endParaRPr lang="it-IT" sz="500" b="1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117" marR="5117" marT="511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5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.1</a:t>
                      </a:r>
                      <a:endParaRPr lang="it-IT" sz="500" b="1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117" marR="5117" marT="511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00B0F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5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4.6</a:t>
                      </a:r>
                      <a:endParaRPr lang="it-IT" sz="500" b="1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117" marR="5117" marT="511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00B0F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5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9</a:t>
                      </a:r>
                      <a:endParaRPr lang="it-IT" sz="500" b="1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117" marR="5117" marT="511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5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500" b="1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4.6</a:t>
                      </a:r>
                      <a:endParaRPr lang="it-IT" sz="500" b="1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117" marR="5117" marT="511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00B0F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500" b="1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.7</a:t>
                      </a:r>
                      <a:endParaRPr lang="it-IT" sz="500" b="1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117" marR="5117" marT="511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00B0F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5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.2</a:t>
                      </a:r>
                      <a:endParaRPr lang="it-IT" sz="500" b="1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117" marR="5117" marT="511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00B0F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t-IT" sz="5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r>
                        <a:rPr lang="it-IT" sz="500" b="1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.p</a:t>
                      </a:r>
                      <a:r>
                        <a:rPr lang="it-IT" sz="5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. </a:t>
                      </a:r>
                      <a:endParaRPr lang="it-IT" sz="500" b="1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117" marR="5117" marT="511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615823877"/>
                  </a:ext>
                </a:extLst>
              </a:tr>
              <a:tr h="133514"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t-IT" sz="5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GFR3::TACC3 V553M</a:t>
                      </a:r>
                      <a:endParaRPr lang="it-IT" sz="500" b="1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117" marR="5117" marT="511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500" b="1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.6</a:t>
                      </a:r>
                    </a:p>
                  </a:txBody>
                  <a:tcPr marL="5117" marR="5117" marT="511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00B0F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500" b="1" i="0" u="none" strike="noStrike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76.5</a:t>
                      </a:r>
                    </a:p>
                  </a:txBody>
                  <a:tcPr marL="5117" marR="5117" marT="511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0070C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500" b="1" i="0" u="none" strike="noStrike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79.4</a:t>
                      </a:r>
                    </a:p>
                  </a:txBody>
                  <a:tcPr marL="5117" marR="5117" marT="511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0070C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500" b="1" i="0" u="none" strike="noStrike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66.3</a:t>
                      </a:r>
                    </a:p>
                  </a:txBody>
                  <a:tcPr marL="5117" marR="5117" marT="511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0070C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500" b="1" i="0" u="none" strike="noStrike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7.6</a:t>
                      </a:r>
                    </a:p>
                  </a:txBody>
                  <a:tcPr marL="5117" marR="5117" marT="511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0070C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500" b="1" u="none" strike="noStrike" kern="1200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68.6</a:t>
                      </a:r>
                    </a:p>
                  </a:txBody>
                  <a:tcPr marL="5117" marR="5117" marT="511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0070C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500" b="1" i="0" u="none" strike="noStrike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83</a:t>
                      </a:r>
                    </a:p>
                  </a:txBody>
                  <a:tcPr marL="5117" marR="5117" marT="511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0070C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500" b="1" i="0" u="none" strike="noStrike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0.9</a:t>
                      </a:r>
                    </a:p>
                  </a:txBody>
                  <a:tcPr marL="5117" marR="5117" marT="511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0070C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t-IT" sz="500" b="1" i="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.p</a:t>
                      </a:r>
                      <a:r>
                        <a:rPr lang="it-IT" sz="500" b="1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.</a:t>
                      </a:r>
                    </a:p>
                  </a:txBody>
                  <a:tcPr marL="5117" marR="5117" marT="511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817972494"/>
                  </a:ext>
                </a:extLst>
              </a:tr>
              <a:tr h="133514">
                <a:tc>
                  <a:txBody>
                    <a:bodyPr/>
                    <a:lstStyle/>
                    <a:p>
                      <a:pPr algn="ctr" fontAlgn="b"/>
                      <a:r>
                        <a:rPr lang="it-IT" sz="5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GFR3::TACC3 V555L</a:t>
                      </a:r>
                      <a:endParaRPr lang="it-IT" sz="500" b="1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117" marR="5117" marT="511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500" b="1" u="none" strike="noStrike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5.2</a:t>
                      </a:r>
                      <a:endParaRPr lang="it-IT" sz="500" b="1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117" marR="5117" marT="511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0070C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500" b="1" u="none" strike="noStrike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84.7</a:t>
                      </a:r>
                      <a:endParaRPr lang="it-IT" sz="500" b="1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117" marR="5117" marT="511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0070C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500" b="1" u="none" strike="noStrike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52</a:t>
                      </a:r>
                      <a:endParaRPr lang="it-IT" sz="500" b="1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117" marR="5117" marT="511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0070C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500" b="1" u="none" strike="noStrike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539.3</a:t>
                      </a:r>
                      <a:endParaRPr lang="it-IT" sz="500" b="1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117" marR="5117" marT="511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0070C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500" b="1" u="none" strike="noStrike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0.1</a:t>
                      </a:r>
                      <a:endParaRPr lang="it-IT" sz="500" b="1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117" marR="5117" marT="511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0070C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500" b="1" u="none" strike="noStrike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06.2</a:t>
                      </a:r>
                      <a:endParaRPr lang="it-IT" sz="500" b="1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117" marR="5117" marT="511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0070C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500" b="1" u="none" strike="noStrike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337.7</a:t>
                      </a:r>
                      <a:endParaRPr lang="it-IT" sz="500" b="1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117" marR="5117" marT="511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0070C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500" b="1" u="none" strike="noStrike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985</a:t>
                      </a:r>
                      <a:endParaRPr lang="it-IT" sz="500" b="1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117" marR="5117" marT="511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0070C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t-IT" sz="5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r>
                        <a:rPr lang="it-IT" sz="500" b="1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.p</a:t>
                      </a:r>
                      <a:r>
                        <a:rPr lang="it-IT" sz="5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. </a:t>
                      </a:r>
                      <a:endParaRPr lang="it-IT" sz="500" b="1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117" marR="5117" marT="511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383213999"/>
                  </a:ext>
                </a:extLst>
              </a:tr>
              <a:tr h="133514">
                <a:tc>
                  <a:txBody>
                    <a:bodyPr/>
                    <a:lstStyle/>
                    <a:p>
                      <a:pPr algn="ctr" rtl="0" fontAlgn="b"/>
                      <a:r>
                        <a:rPr lang="it-IT" sz="5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FGFR3::TACC3 V555M</a:t>
                      </a:r>
                    </a:p>
                  </a:txBody>
                  <a:tcPr marL="5358" marR="5358" marT="535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it-IT" sz="500" b="1" i="0" u="none" strike="noStrike" dirty="0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</a:rPr>
                        <a:t>95.9</a:t>
                      </a:r>
                    </a:p>
                  </a:txBody>
                  <a:tcPr marL="5358" marR="5358" marT="535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0070C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it-IT" sz="500" b="1" i="0" u="none" strike="noStrike" dirty="0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</a:rPr>
                        <a:t>327.2</a:t>
                      </a:r>
                    </a:p>
                  </a:txBody>
                  <a:tcPr marL="5358" marR="5358" marT="535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0070C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it-IT" sz="500" b="1" i="0" u="none" strike="noStrike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</a:rPr>
                        <a:t>1695</a:t>
                      </a:r>
                    </a:p>
                  </a:txBody>
                  <a:tcPr marL="5358" marR="5358" marT="535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0070C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it-IT" sz="500" b="1" i="0" u="none" strike="noStrike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</a:rPr>
                        <a:t>7018</a:t>
                      </a:r>
                    </a:p>
                  </a:txBody>
                  <a:tcPr marL="5358" marR="5358" marT="535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0070C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it-IT" sz="500" b="1" i="0" u="none" strike="noStrike" dirty="0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</a:rPr>
                        <a:t>721.7</a:t>
                      </a:r>
                    </a:p>
                  </a:txBody>
                  <a:tcPr marL="5358" marR="5358" marT="535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0070C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it-IT" sz="500" b="1" i="0" u="none" strike="noStrike" dirty="0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</a:rPr>
                        <a:t>419.8</a:t>
                      </a:r>
                    </a:p>
                  </a:txBody>
                  <a:tcPr marL="5358" marR="5358" marT="535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0070C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it-IT" sz="500" b="1" i="0" u="none" strike="noStrike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</a:rPr>
                        <a:t>514.8</a:t>
                      </a:r>
                    </a:p>
                  </a:txBody>
                  <a:tcPr marL="5358" marR="5358" marT="535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0070C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it-IT" sz="500" b="1" i="0" u="none" strike="noStrike" dirty="0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</a:rPr>
                        <a:t>1515</a:t>
                      </a:r>
                    </a:p>
                  </a:txBody>
                  <a:tcPr marL="5358" marR="5358" marT="535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0070C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t-IT" sz="500" b="1" i="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.p</a:t>
                      </a:r>
                      <a:r>
                        <a:rPr lang="it-IT" sz="500" b="1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.</a:t>
                      </a:r>
                    </a:p>
                  </a:txBody>
                  <a:tcPr marL="5117" marR="5117" marT="511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759413413"/>
                  </a:ext>
                </a:extLst>
              </a:tr>
              <a:tr h="133514">
                <a:tc>
                  <a:txBody>
                    <a:bodyPr/>
                    <a:lstStyle/>
                    <a:p>
                      <a:pPr algn="ctr" fontAlgn="b"/>
                      <a:r>
                        <a:rPr lang="it-IT" sz="5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GFR3::TACC3 L608V</a:t>
                      </a:r>
                      <a:endParaRPr lang="it-IT" sz="500" b="1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117" marR="5117" marT="511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500" b="1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.8</a:t>
                      </a:r>
                      <a:endParaRPr lang="it-IT" sz="500" b="1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117" marR="5117" marT="511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00B0F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500" b="1" u="none" strike="noStrike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8.2</a:t>
                      </a:r>
                      <a:endParaRPr lang="it-IT" sz="500" b="1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117" marR="5117" marT="511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0070C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500" b="1" u="none" strike="noStrike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4.8</a:t>
                      </a:r>
                      <a:endParaRPr lang="it-IT" sz="500" b="1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117" marR="5117" marT="511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0070C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500" b="1" u="none" strike="noStrike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72.6</a:t>
                      </a:r>
                      <a:endParaRPr lang="it-IT" sz="500" b="1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117" marR="5117" marT="511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0070C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500" b="1" u="none" strike="noStrike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.9</a:t>
                      </a:r>
                      <a:endParaRPr lang="it-IT" sz="500" b="1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117" marR="5117" marT="511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0070C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500" b="1" u="none" strike="noStrike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31.3</a:t>
                      </a:r>
                      <a:endParaRPr lang="it-IT" sz="500" b="1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117" marR="5117" marT="511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0070C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500" b="1" u="none" strike="noStrike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5</a:t>
                      </a:r>
                      <a:endParaRPr lang="it-IT" sz="500" b="1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117" marR="5117" marT="511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0070C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500" b="1" u="none" strike="noStrike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808.5</a:t>
                      </a:r>
                      <a:endParaRPr lang="it-IT" sz="500" b="1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117" marR="5117" marT="511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0070C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t-IT" sz="5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r>
                        <a:rPr lang="it-IT" sz="500" b="1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.p</a:t>
                      </a:r>
                      <a:r>
                        <a:rPr lang="it-IT" sz="5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. </a:t>
                      </a:r>
                      <a:endParaRPr lang="it-IT" sz="500" b="1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117" marR="5117" marT="511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4084184037"/>
                  </a:ext>
                </a:extLst>
              </a:tr>
            </a:tbl>
          </a:graphicData>
        </a:graphic>
      </p:graphicFrame>
      <p:sp>
        <p:nvSpPr>
          <p:cNvPr id="6" name="CasellaDiTesto 5">
            <a:extLst>
              <a:ext uri="{FF2B5EF4-FFF2-40B4-BE49-F238E27FC236}">
                <a16:creationId xmlns:a16="http://schemas.microsoft.com/office/drawing/2014/main" id="{951895F5-A974-6F49-095F-46E26423B92F}"/>
              </a:ext>
            </a:extLst>
          </p:cNvPr>
          <p:cNvSpPr txBox="1"/>
          <p:nvPr/>
        </p:nvSpPr>
        <p:spPr>
          <a:xfrm>
            <a:off x="248782" y="693656"/>
            <a:ext cx="1151792" cy="169277"/>
          </a:xfrm>
          <a:prstGeom prst="rect">
            <a:avLst/>
          </a:prstGeom>
          <a:solidFill>
            <a:srgbClr val="00B0F0"/>
          </a:solidFill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it-IT" sz="500" b="1" dirty="0">
                <a:latin typeface="Arial" panose="020B0604020202020204" pitchFamily="34" charset="0"/>
                <a:cs typeface="Arial" panose="020B0604020202020204" pitchFamily="34" charset="0"/>
              </a:rPr>
              <a:t>5≤nM&lt;20 </a:t>
            </a:r>
            <a:r>
              <a:rPr lang="it-IT" sz="500" b="1" dirty="0" err="1">
                <a:latin typeface="Arial" panose="020B0604020202020204" pitchFamily="34" charset="0"/>
                <a:cs typeface="Arial" panose="020B0604020202020204" pitchFamily="34" charset="0"/>
              </a:rPr>
              <a:t>nM</a:t>
            </a:r>
            <a:r>
              <a:rPr lang="it-IT" sz="500" b="1" dirty="0">
                <a:latin typeface="Arial" panose="020B0604020202020204" pitchFamily="34" charset="0"/>
                <a:cs typeface="Arial" panose="020B0604020202020204" pitchFamily="34" charset="0"/>
              </a:rPr>
              <a:t> intermediate</a:t>
            </a:r>
          </a:p>
        </p:txBody>
      </p:sp>
      <p:sp>
        <p:nvSpPr>
          <p:cNvPr id="7" name="CasellaDiTesto 6">
            <a:extLst>
              <a:ext uri="{FF2B5EF4-FFF2-40B4-BE49-F238E27FC236}">
                <a16:creationId xmlns:a16="http://schemas.microsoft.com/office/drawing/2014/main" id="{4A57F02D-480F-E90D-22E0-5B371EDAEEA6}"/>
              </a:ext>
            </a:extLst>
          </p:cNvPr>
          <p:cNvSpPr txBox="1"/>
          <p:nvPr/>
        </p:nvSpPr>
        <p:spPr>
          <a:xfrm>
            <a:off x="248782" y="882476"/>
            <a:ext cx="1151792" cy="169277"/>
          </a:xfrm>
          <a:prstGeom prst="rect">
            <a:avLst/>
          </a:prstGeom>
          <a:solidFill>
            <a:srgbClr val="0070C0"/>
          </a:solidFill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 fontAlgn="b"/>
            <a:r>
              <a:rPr lang="it-IT" sz="5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≥20 </a:t>
            </a:r>
            <a:r>
              <a:rPr lang="it-IT" sz="500" b="1" dirty="0" err="1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M</a:t>
            </a:r>
            <a:r>
              <a:rPr lang="it-IT" sz="5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it-IT" sz="500" b="1" dirty="0" err="1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esistant</a:t>
            </a:r>
            <a:endParaRPr lang="it-IT" sz="5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CasellaDiTesto 1">
            <a:extLst>
              <a:ext uri="{FF2B5EF4-FFF2-40B4-BE49-F238E27FC236}">
                <a16:creationId xmlns:a16="http://schemas.microsoft.com/office/drawing/2014/main" id="{7ED7DB4F-71DE-3693-1037-FC5C46363668}"/>
              </a:ext>
            </a:extLst>
          </p:cNvPr>
          <p:cNvSpPr txBox="1"/>
          <p:nvPr/>
        </p:nvSpPr>
        <p:spPr>
          <a:xfrm>
            <a:off x="0" y="48549"/>
            <a:ext cx="213019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Supplementary</a:t>
            </a:r>
            <a:r>
              <a:rPr lang="it-IT" sz="14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it-IT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Table</a:t>
            </a:r>
            <a:r>
              <a:rPr lang="it-IT" sz="1400" b="1" dirty="0">
                <a:latin typeface="Arial" panose="020B0604020202020204" pitchFamily="34" charset="0"/>
                <a:cs typeface="Arial" panose="020B0604020202020204" pitchFamily="34" charset="0"/>
              </a:rPr>
              <a:t> 3</a:t>
            </a:r>
          </a:p>
        </p:txBody>
      </p:sp>
      <p:sp>
        <p:nvSpPr>
          <p:cNvPr id="8" name="CasellaDiTesto 7">
            <a:extLst>
              <a:ext uri="{FF2B5EF4-FFF2-40B4-BE49-F238E27FC236}">
                <a16:creationId xmlns:a16="http://schemas.microsoft.com/office/drawing/2014/main" id="{1FB0CC19-4D50-70E8-FA6C-4565275D1590}"/>
              </a:ext>
            </a:extLst>
          </p:cNvPr>
          <p:cNvSpPr txBox="1"/>
          <p:nvPr/>
        </p:nvSpPr>
        <p:spPr>
          <a:xfrm>
            <a:off x="248781" y="2673815"/>
            <a:ext cx="6397551" cy="144879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sz="10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upplementary Table 3. IC50 values of Ba/F3 cells harboring FGFR3:TACC3 mutants exposed to eight selective FGFR inhibitors.</a:t>
            </a:r>
            <a:endParaRPr lang="it-IT" sz="1000" dirty="0">
              <a:effectLst/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 algn="just">
              <a:lnSpc>
                <a:spcPct val="150000"/>
              </a:lnSpc>
            </a:pPr>
            <a:r>
              <a:rPr lang="en-US" sz="1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The observation that a FGFR3 V553L and V553M mutations emerged in patients progressing respectively on </a:t>
            </a:r>
            <a:r>
              <a:rPr lang="en-US" sz="1000" dirty="0" err="1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pemigatinib</a:t>
            </a:r>
            <a:r>
              <a:rPr lang="en-US" sz="1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(MR406) and erdafitinib (ST3010), together with the spectrum of mutations emerging across patients, prompted us to propose the cut-off of sensitivity/resistance. </a:t>
            </a:r>
            <a:endParaRPr lang="it-IT" sz="1000" dirty="0">
              <a:effectLst/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 algn="just">
              <a:lnSpc>
                <a:spcPct val="150000"/>
              </a:lnSpc>
            </a:pPr>
            <a:r>
              <a:rPr lang="en-US" sz="1000" dirty="0" err="1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n.p.</a:t>
            </a:r>
            <a:r>
              <a:rPr lang="en-US" sz="1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: Not performed. </a:t>
            </a:r>
            <a:endParaRPr lang="it-IT" sz="1000" dirty="0">
              <a:effectLst/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774577631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Tema di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i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i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2338</TotalTime>
  <Words>245</Words>
  <Application>Microsoft Macintosh PowerPoint</Application>
  <PresentationFormat>A4 (21x29,7 cm)</PresentationFormat>
  <Paragraphs>98</Paragraphs>
  <Slides>1</Slides>
  <Notes>0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3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ema di Office</vt:lpstr>
      <vt:lpstr>Presentazione standard di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Francesco Facchinetti</dc:creator>
  <cp:lastModifiedBy>Francesco Facchinetti</cp:lastModifiedBy>
  <cp:revision>82</cp:revision>
  <dcterms:created xsi:type="dcterms:W3CDTF">2022-12-10T11:29:14Z</dcterms:created>
  <dcterms:modified xsi:type="dcterms:W3CDTF">2023-04-01T16:47:09Z</dcterms:modified>
</cp:coreProperties>
</file>